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49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E585A1-1930-79F4-4F1C-ADE1687F8D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7D51F14-E07D-7396-89F0-6F899E83FA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718A1C-F02F-0C01-6227-C85218476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F0A71F-397C-AE1F-4917-34B856D57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C82089-A1BA-F305-325A-7E0AC89C6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793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CE0497-6E9F-193F-5B77-A8530F177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9AEF53B-855B-5EDF-6157-88360C2B80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DEC32B-C607-2502-38C1-7664E7772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31BA23-7C2C-4478-94CB-EB1124166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344F9E-7CFA-1FF3-58A2-2C81E3777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67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C92BC1D-B01F-5C5A-72D0-924A8387DA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7B6FBF8-FEAF-D645-D077-464C5BCE28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9C68ED-38EF-8911-527D-A763C2729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4DD1E8-E203-C8F2-C997-2C15F2543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AE1C50-8B83-B08B-C0D2-41EA29453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12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62D0EB-9F83-B896-0F8C-9F5825E31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D30DE6-369C-48D8-DB0C-83DA00F3A6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45256C-1E8F-4549-D26C-D424C91F9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81EF77-C5D1-E782-9B10-9FC6AE2E9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738047-6F02-B020-57DC-789129030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250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C78FA1-8802-9EAE-905C-3B40B8A839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8F4152-7932-C004-C271-0E1AD5394F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1B86F5-7315-9258-82D7-46DBB3C70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0542AA-2EEE-8412-3D80-B3FA772FE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F2D4BA-9660-5F47-0CA8-63C5D889A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105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E8F19F-14AB-851E-A4D0-D205793BB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0C6B72-78DF-6984-614F-7330153A88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F41424-7A3A-B945-B74F-418556900D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F079A0-06F8-3830-EF27-6220B4B9F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A6418F-C977-431B-EB60-3D5ACD578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F53AD36-7C60-D0E7-F620-1453B7A77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009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811C89-5B78-CDEC-5993-504C0ADF5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4697B1-3FD6-413A-136B-0C558AA4CE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319D54-2572-A0B0-B2C1-449EC70A76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5D68D5F-80A6-5E0F-5788-5B65E74068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217CC2A-F33C-DFFD-F194-1D382AA947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564079B-EB10-A184-84C0-A0F9F4F98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359F2A4-27C7-C901-C232-CEA189970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4560EB8-F464-47CE-9459-1D13571DE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5865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61A3B1-0EDC-1BDA-A0E1-CA3BFF4D23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B699AF5-AF72-1B85-493B-0CE2FCDB2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C6A66D3-0CAC-B958-5860-D9C75A581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3BC9799-8D7D-469A-D38C-D49C222A7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726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A4C9733-885D-4D64-4A9A-34BBA3C6C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D37643E-A65F-D3B4-0B06-49A311E3B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C04A349-82BD-9916-1A75-6D9A93304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236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7B78E6-E097-EF50-EE81-CFC08A128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8702C3-C20A-5367-ED3A-C183F2A213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67FBFF-9722-AA63-3396-7CECCBF9DE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8445A7-7054-D471-5BF5-C193116D9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FC7B41-6F55-3EF5-30A7-3A875D7C9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9E5DAA-2E8C-D176-2EF0-20D882B78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551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E0EAD6-CFA3-6475-751D-B859463C5F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C86E35E-F43D-A273-458E-5B197EB357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5299AF8-2419-C9E2-1ADB-E3BBFF3410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FB32EA-B8C6-0B51-B12A-1BB71D6BC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4D6521-F756-4E5E-FA70-8B6B5448E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571EBB-3D2F-6B9E-1E66-F03DE7934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866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CF5403F-DB96-AB11-658F-ABD05B0D0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43700C-03EC-E601-8C70-755DC964AF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E7AF45-1066-9329-AB94-5133A0200B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0BA6B8-8CD4-469A-89D2-EA53259DE7B4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46E6B1-99A9-CE90-12D2-D6240B6625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90AC4F-67B0-B08E-E0C4-5D193F07DB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B0B515-8BCC-4EC7-8C30-CCFADDFCE9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862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1F5C41-DD20-941A-64A7-B77537965C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88488" y="1270159"/>
            <a:ext cx="9144000" cy="2387600"/>
          </a:xfrm>
        </p:spPr>
        <p:txBody>
          <a:bodyPr/>
          <a:lstStyle/>
          <a:p>
            <a:r>
              <a:rPr lang="en-US" altLang="zh-CN" dirty="0"/>
              <a:t>Supplementary Figures</a:t>
            </a: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AE13A4A-9406-59E3-ECCE-9A06CC7852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65760" y="442278"/>
            <a:ext cx="11460480" cy="1655762"/>
          </a:xfrm>
        </p:spPr>
        <p:txBody>
          <a:bodyPr>
            <a:normAutofit/>
          </a:bodyPr>
          <a:lstStyle/>
          <a:p>
            <a:pPr algn="l"/>
            <a:r>
              <a:rPr lang="en-US" altLang="zh-CN" dirty="0"/>
              <a:t>Leguminous cover crops and soya increased soil fungal diversity and </a:t>
            </a:r>
            <a:endParaRPr lang="en-US" altLang="zh-CN" dirty="0" smtClean="0"/>
          </a:p>
          <a:p>
            <a:pPr algn="l"/>
            <a:r>
              <a:rPr lang="en-US" altLang="zh-CN" dirty="0" smtClean="0"/>
              <a:t>suppressed </a:t>
            </a:r>
            <a:r>
              <a:rPr lang="en-US" altLang="zh-CN" dirty="0" err="1"/>
              <a:t>pathotrophs</a:t>
            </a:r>
            <a:r>
              <a:rPr lang="en-US" altLang="zh-CN" dirty="0"/>
              <a:t> caused by continuous cereal croppin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99736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42A4614-2A12-A8FC-171C-B2AF68F159CA}"/>
              </a:ext>
            </a:extLst>
          </p:cNvPr>
          <p:cNvSpPr txBox="1"/>
          <p:nvPr/>
        </p:nvSpPr>
        <p:spPr>
          <a:xfrm>
            <a:off x="1025672" y="5809206"/>
            <a:ext cx="10474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b="1" kern="22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sz="1800" b="1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800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eatments (A) and spatial layout (B) of crop rotation systems. Red dots in (A) showed sampling points. </a:t>
            </a:r>
            <a:r>
              <a:rPr lang="en-US" altLang="zh-CN" sz="1800" kern="2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etchRye</a:t>
            </a:r>
            <a:r>
              <a:rPr lang="en-US" altLang="zh-CN" sz="1800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vetch and ryegrass mixture. 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640" y="366903"/>
            <a:ext cx="7081343" cy="5092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9798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4B14359-CCD2-59F8-5E22-F7C34C1349F8}"/>
              </a:ext>
            </a:extLst>
          </p:cNvPr>
          <p:cNvSpPr txBox="1"/>
          <p:nvPr/>
        </p:nvSpPr>
        <p:spPr>
          <a:xfrm>
            <a:off x="461146" y="5604405"/>
            <a:ext cx="113182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b="1" kern="22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zh-CN" sz="1800" b="1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800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rarefaction curves of different cropping systems. The vertical line indicates the number of sequences subsampled from each sample that were used to calculate fungal diversity and community composition estimates (</a:t>
            </a:r>
            <a:r>
              <a:rPr lang="en-US" altLang="zh-CN" sz="1800" b="1" kern="2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1</a:t>
            </a:r>
            <a:r>
              <a:rPr lang="en-US" altLang="zh-CN" sz="1800" kern="22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6788" y="1071775"/>
            <a:ext cx="6446956" cy="4197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8485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569976" y="4131911"/>
            <a:ext cx="1105204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</a:t>
            </a:r>
            <a:r>
              <a:rPr lang="en-US" altLang="zh-CN" b="1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Principal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coordinate analysis (</a:t>
            </a:r>
            <a:r>
              <a:rPr lang="en-US" altLang="zh-CN" kern="2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PCoA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) of the Bray-Curtis distances of fungal communities at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OTU level, showing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the effect of cropping system conversion (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A),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and cover crops followed by soya (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B)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and maize (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C).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The average of rotation systems is presented as square markers ± standard error (before experiment, n = 3; new rotation systems, n = 8). The asterisks following the determination coefficient (R</a:t>
            </a:r>
            <a:r>
              <a:rPr lang="en-US" altLang="zh-CN" kern="2200" baseline="30000" dirty="0"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) indicate the significant differences at </a:t>
            </a:r>
            <a:r>
              <a:rPr lang="en-US" altLang="zh-CN" i="1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 &lt; 0.05 (*),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0.01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(**) or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0.001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(***) based on the </a:t>
            </a:r>
            <a:r>
              <a:rPr lang="en-US" altLang="zh-CN" kern="2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permutational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 multivariate analysis of variance (PERMANOVA). CCB, cover crop biomass; Pa, </a:t>
            </a:r>
            <a:r>
              <a:rPr lang="en-US" altLang="zh-CN" kern="2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pathotroph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; Sa, saprotroph; </a:t>
            </a:r>
            <a:r>
              <a:rPr lang="en-US" altLang="zh-CN" kern="2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Sy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altLang="zh-CN" kern="2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symbiotroph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Abbreviations of soil properties are listed in </a:t>
            </a:r>
            <a:r>
              <a:rPr lang="en-US" altLang="zh-CN" b="1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Table 1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428" y="1089168"/>
            <a:ext cx="10058400" cy="2689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21470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718" y="1724565"/>
            <a:ext cx="10446132" cy="2341404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682312" y="4512041"/>
            <a:ext cx="1081645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</a:t>
            </a:r>
            <a:r>
              <a:rPr lang="en-US" altLang="zh-CN" b="1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Random forest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mean predictor importance (% of increase in MSE) of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the environmental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factors as predictors of 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the relative abundances of </a:t>
            </a:r>
            <a:r>
              <a:rPr lang="en-US" altLang="zh-CN" kern="2200" dirty="0" err="1" smtClean="0">
                <a:latin typeface="Times New Roman" panose="02020603050405020304" pitchFamily="18" charset="0"/>
                <a:ea typeface="宋体" panose="02010600030101010101" pitchFamily="2" charset="-122"/>
              </a:rPr>
              <a:t>pathotroph</a:t>
            </a:r>
            <a:r>
              <a:rPr lang="en-US" altLang="zh-CN" kern="2200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, saprotroph, and </a:t>
            </a:r>
            <a:r>
              <a:rPr lang="en-US" altLang="zh-CN" kern="2200" dirty="0" err="1" smtClean="0">
                <a:latin typeface="Times New Roman" panose="02020603050405020304" pitchFamily="18" charset="0"/>
                <a:ea typeface="宋体" panose="02010600030101010101" pitchFamily="2" charset="-122"/>
              </a:rPr>
              <a:t>symbiotroph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kern="2200">
                <a:latin typeface="Times New Roman" panose="02020603050405020304" pitchFamily="18" charset="0"/>
                <a:ea typeface="宋体" panose="02010600030101010101" pitchFamily="2" charset="-122"/>
              </a:rPr>
              <a:t>Asterisks </a:t>
            </a:r>
            <a:r>
              <a:rPr lang="en-US" altLang="zh-CN" kern="2200" smtClean="0">
                <a:latin typeface="Times New Roman" panose="02020603050405020304" pitchFamily="18" charset="0"/>
                <a:ea typeface="宋体" panose="02010600030101010101" pitchFamily="2" charset="-122"/>
              </a:rPr>
              <a:t>indicate 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significances of the correlation at </a:t>
            </a:r>
            <a:r>
              <a:rPr lang="en-US" altLang="zh-CN" i="1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en-US" altLang="zh-CN" kern="2200" dirty="0">
                <a:latin typeface="Times New Roman" panose="02020603050405020304" pitchFamily="18" charset="0"/>
                <a:ea typeface="宋体" panose="02010600030101010101" pitchFamily="2" charset="-122"/>
              </a:rPr>
              <a:t> &lt; 0.05 (*), 0.01 (**), or 0.001 (***)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1274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76</Words>
  <Application>Microsoft Office PowerPoint</Application>
  <PresentationFormat>宽屏</PresentationFormat>
  <Paragraphs>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Times New Roman</vt:lpstr>
      <vt:lpstr>Office 主题​​</vt:lpstr>
      <vt:lpstr>Supplementary Figures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王 天舒</dc:creator>
  <cp:lastModifiedBy>wangts</cp:lastModifiedBy>
  <cp:revision>7</cp:revision>
  <dcterms:created xsi:type="dcterms:W3CDTF">2022-07-13T10:20:26Z</dcterms:created>
  <dcterms:modified xsi:type="dcterms:W3CDTF">2022-09-14T06:59:50Z</dcterms:modified>
</cp:coreProperties>
</file>